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90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5884"/>
  </p:normalViewPr>
  <p:slideViewPr>
    <p:cSldViewPr snapToGrid="0">
      <p:cViewPr varScale="1">
        <p:scale>
          <a:sx n="127" d="100"/>
          <a:sy n="127" d="100"/>
        </p:scale>
        <p:origin x="164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582EE-A106-DB42-9403-11644E6A4533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730FD-E74C-6346-87FF-3BA0D0BDDC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38235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582EE-A106-DB42-9403-11644E6A4533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730FD-E74C-6346-87FF-3BA0D0BDDC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2691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582EE-A106-DB42-9403-11644E6A4533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730FD-E74C-6346-87FF-3BA0D0BDDC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4414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582EE-A106-DB42-9403-11644E6A4533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730FD-E74C-6346-87FF-3BA0D0BDDC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01286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582EE-A106-DB42-9403-11644E6A4533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730FD-E74C-6346-87FF-3BA0D0BDDC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43838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582EE-A106-DB42-9403-11644E6A4533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730FD-E74C-6346-87FF-3BA0D0BDDC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41120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582EE-A106-DB42-9403-11644E6A4533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730FD-E74C-6346-87FF-3BA0D0BDDC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93712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582EE-A106-DB42-9403-11644E6A4533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730FD-E74C-6346-87FF-3BA0D0BDDC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75105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582EE-A106-DB42-9403-11644E6A4533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730FD-E74C-6346-87FF-3BA0D0BDDC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70434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582EE-A106-DB42-9403-11644E6A4533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730FD-E74C-6346-87FF-3BA0D0BDDC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97122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582EE-A106-DB42-9403-11644E6A4533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730FD-E74C-6346-87FF-3BA0D0BDDC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00597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6582EE-A106-DB42-9403-11644E6A4533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E730FD-E74C-6346-87FF-3BA0D0BDDC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68431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68FED38E-B6CE-917B-D21E-03B7C82CEB5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29442" y="156681"/>
            <a:ext cx="5026509" cy="5849816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DF71AD1-EC61-F995-57A6-4919BD7F4F14}"/>
              </a:ext>
            </a:extLst>
          </p:cNvPr>
          <p:cNvSpPr txBox="1"/>
          <p:nvPr/>
        </p:nvSpPr>
        <p:spPr>
          <a:xfrm>
            <a:off x="257907" y="6006497"/>
            <a:ext cx="8628185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Figure S2</a:t>
            </a:r>
            <a:r>
              <a:rPr kumimoji="1" lang="en-US" altLang="ja-JP" sz="11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  </a:t>
            </a: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Effect of bio-priming by </a:t>
            </a:r>
            <a:r>
              <a:rPr kumimoji="0" lang="en-US" altLang="ja-JP" sz="11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R. </a:t>
            </a:r>
            <a:r>
              <a:rPr kumimoji="0" lang="en-US" altLang="ja-JP" sz="1100" b="0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phaeroides</a:t>
            </a:r>
            <a:r>
              <a:rPr kumimoji="0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NBRC 12203</a:t>
            </a:r>
            <a:r>
              <a:rPr kumimoji="0" lang="en-US" altLang="ja-JP" sz="11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</a:t>
            </a:r>
            <a:r>
              <a:rPr kumimoji="0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(dead cell) </a:t>
            </a: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on (a) root length, (b) surface area, (c) number of tips, (d) number of forks, and (e) % of thin (0.1 mm &lt; diameter) roots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The rice seeds were bio-primed by PNSB for 24 hours, sown onto cell pot and cultivated for 14 days. </a:t>
            </a:r>
            <a:r>
              <a:rPr kumimoji="0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Data are means </a:t>
            </a:r>
            <a:r>
              <a:rPr kumimoji="0" lang="en-US" altLang="ja-JP" sz="1100" b="0" i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+</a:t>
            </a:r>
            <a:r>
              <a:rPr kumimoji="0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 SD (n = 5). Asterisk indicates the result that was significantly different (* p&lt;0.05) from the control.</a:t>
            </a:r>
            <a:r>
              <a:rPr kumimoji="0" lang="ja-JP" altLang="ja-JP" sz="11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34" charset="-128"/>
                <a:cs typeface="Arial" panose="020B0604020202020204" pitchFamily="34" charset="0"/>
              </a:rPr>
              <a:t> </a:t>
            </a:r>
            <a:endParaRPr kumimoji="1" lang="en-US" altLang="ja-JP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BE4EEF8-3E7D-C53B-1C42-C611D67725A5}"/>
              </a:ext>
            </a:extLst>
          </p:cNvPr>
          <p:cNvSpPr txBox="1"/>
          <p:nvPr/>
        </p:nvSpPr>
        <p:spPr>
          <a:xfrm>
            <a:off x="140676" y="109789"/>
            <a:ext cx="132470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Figure S2</a:t>
            </a:r>
            <a:r>
              <a:rPr kumimoji="1" lang="en-US" altLang="ja-JP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 </a:t>
            </a:r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3066828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0</TotalTime>
  <Words>106</Words>
  <Application>Microsoft Macintosh PowerPoint</Application>
  <PresentationFormat>画面に合わせる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宮坂 研究室</dc:creator>
  <cp:lastModifiedBy>宮坂均</cp:lastModifiedBy>
  <cp:revision>5</cp:revision>
  <dcterms:created xsi:type="dcterms:W3CDTF">2022-10-28T23:54:50Z</dcterms:created>
  <dcterms:modified xsi:type="dcterms:W3CDTF">2022-11-01T10:17:59Z</dcterms:modified>
</cp:coreProperties>
</file>